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43" r:id="rId2"/>
  </p:sldIdLst>
  <p:sldSz cx="9144000" cy="6858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740" autoAdjust="0"/>
    <p:restoredTop sz="93892" autoAdjust="0"/>
  </p:normalViewPr>
  <p:slideViewPr>
    <p:cSldViewPr snapToObjects="1">
      <p:cViewPr varScale="1">
        <p:scale>
          <a:sx n="87" d="100"/>
          <a:sy n="87" d="100"/>
        </p:scale>
        <p:origin x="1736" y="5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36004" cy="36004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F1648205-0EC5-BF46-91E5-90DE993D243C}" type="datetimeFigureOut">
              <a:rPr lang="en-US" smtClean="0"/>
              <a:t>2/27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81100" y="696913"/>
            <a:ext cx="4648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15790"/>
            <a:ext cx="5608320" cy="4183380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6A63B486-E09D-CE44-A456-9AA628F96C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871525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ABA525-F017-4DAF-8C93-269222737508}" type="datetimeFigureOut">
              <a:rPr lang="en-US" smtClean="0"/>
              <a:t>2/2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2DEAD0-CCFD-47E2-8BE0-99CC0B6D50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61472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ABA525-F017-4DAF-8C93-269222737508}" type="datetimeFigureOut">
              <a:rPr lang="en-US" smtClean="0"/>
              <a:t>2/2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2DEAD0-CCFD-47E2-8BE0-99CC0B6D50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93301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ABA525-F017-4DAF-8C93-269222737508}" type="datetimeFigureOut">
              <a:rPr lang="en-US" smtClean="0"/>
              <a:t>2/2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2DEAD0-CCFD-47E2-8BE0-99CC0B6D50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86434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ABA525-F017-4DAF-8C93-269222737508}" type="datetimeFigureOut">
              <a:rPr lang="en-US" smtClean="0"/>
              <a:t>2/2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2DEAD0-CCFD-47E2-8BE0-99CC0B6D50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63594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ABA525-F017-4DAF-8C93-269222737508}" type="datetimeFigureOut">
              <a:rPr lang="en-US" smtClean="0"/>
              <a:t>2/2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2DEAD0-CCFD-47E2-8BE0-99CC0B6D50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4304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ABA525-F017-4DAF-8C93-269222737508}" type="datetimeFigureOut">
              <a:rPr lang="en-US" smtClean="0"/>
              <a:t>2/27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2DEAD0-CCFD-47E2-8BE0-99CC0B6D50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2217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ABA525-F017-4DAF-8C93-269222737508}" type="datetimeFigureOut">
              <a:rPr lang="en-US" smtClean="0"/>
              <a:t>2/27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2DEAD0-CCFD-47E2-8BE0-99CC0B6D50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39782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ABA525-F017-4DAF-8C93-269222737508}" type="datetimeFigureOut">
              <a:rPr lang="en-US" smtClean="0"/>
              <a:t>2/27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2DEAD0-CCFD-47E2-8BE0-99CC0B6D50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82787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ABA525-F017-4DAF-8C93-269222737508}" type="datetimeFigureOut">
              <a:rPr lang="en-US" smtClean="0"/>
              <a:t>2/27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2DEAD0-CCFD-47E2-8BE0-99CC0B6D50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24538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ABA525-F017-4DAF-8C93-269222737508}" type="datetimeFigureOut">
              <a:rPr lang="en-US" smtClean="0"/>
              <a:t>2/27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2DEAD0-CCFD-47E2-8BE0-99CC0B6D50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27997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ABA525-F017-4DAF-8C93-269222737508}" type="datetimeFigureOut">
              <a:rPr lang="en-US" smtClean="0"/>
              <a:t>2/27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2DEAD0-CCFD-47E2-8BE0-99CC0B6D50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90568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ABA525-F017-4DAF-8C93-269222737508}" type="datetimeFigureOut">
              <a:rPr lang="en-US" smtClean="0"/>
              <a:t>2/2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2DEAD0-CCFD-47E2-8BE0-99CC0B6D50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44993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3E4FE9C5-9BAC-449E-A1A3-FC2A66051B9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31557877"/>
              </p:ext>
            </p:extLst>
          </p:nvPr>
        </p:nvGraphicFramePr>
        <p:xfrm>
          <a:off x="575556" y="2411463"/>
          <a:ext cx="7848871" cy="3592830"/>
        </p:xfrm>
        <a:graphic>
          <a:graphicData uri="http://schemas.openxmlformats.org/drawingml/2006/table">
            <a:tbl>
              <a:tblPr/>
              <a:tblGrid>
                <a:gridCol w="648072">
                  <a:extLst>
                    <a:ext uri="{9D8B030D-6E8A-4147-A177-3AD203B41FA5}">
                      <a16:colId xmlns:a16="http://schemas.microsoft.com/office/drawing/2014/main" val="4140091643"/>
                    </a:ext>
                  </a:extLst>
                </a:gridCol>
                <a:gridCol w="2052228">
                  <a:extLst>
                    <a:ext uri="{9D8B030D-6E8A-4147-A177-3AD203B41FA5}">
                      <a16:colId xmlns:a16="http://schemas.microsoft.com/office/drawing/2014/main" val="3708696878"/>
                    </a:ext>
                  </a:extLst>
                </a:gridCol>
                <a:gridCol w="1303848">
                  <a:extLst>
                    <a:ext uri="{9D8B030D-6E8A-4147-A177-3AD203B41FA5}">
                      <a16:colId xmlns:a16="http://schemas.microsoft.com/office/drawing/2014/main" val="237010448"/>
                    </a:ext>
                  </a:extLst>
                </a:gridCol>
                <a:gridCol w="1092040">
                  <a:extLst>
                    <a:ext uri="{9D8B030D-6E8A-4147-A177-3AD203B41FA5}">
                      <a16:colId xmlns:a16="http://schemas.microsoft.com/office/drawing/2014/main" val="3079100765"/>
                    </a:ext>
                  </a:extLst>
                </a:gridCol>
                <a:gridCol w="1248046">
                  <a:extLst>
                    <a:ext uri="{9D8B030D-6E8A-4147-A177-3AD203B41FA5}">
                      <a16:colId xmlns:a16="http://schemas.microsoft.com/office/drawing/2014/main" val="560095997"/>
                    </a:ext>
                  </a:extLst>
                </a:gridCol>
                <a:gridCol w="1504637">
                  <a:extLst>
                    <a:ext uri="{9D8B030D-6E8A-4147-A177-3AD203B41FA5}">
                      <a16:colId xmlns:a16="http://schemas.microsoft.com/office/drawing/2014/main" val="1113267335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me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pressed gene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ignal peptide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moter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erminator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ference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24768582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LS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GII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pDEX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spyk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sgal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i et al. 201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37690283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LS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eTrCBHI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pDEX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spyk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sgal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i et al. 201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04985686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LS1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usion 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pDEX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spyk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sgal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is study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98370190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LS1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usion 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pDEX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spyk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sgal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is study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95186520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LS1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usion 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pDEX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spyk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sgal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is study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00590270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1f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D1214-AA + Fusion 3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-A-amylase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TEF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CYC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his study </a:t>
                      </a:r>
                      <a:endParaRPr kumimoji="0" lang="en-US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55251611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2f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D1214-SA + Fusion 3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rum albumi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TEF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CYC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his study </a:t>
                      </a:r>
                      <a:endParaRPr kumimoji="0" lang="en-US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17133916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3f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D1214-AK + Fusion 3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-</a:t>
                      </a:r>
                      <a:r>
                        <a:rPr lang="en-US" sz="12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lphafactor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TEF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CYC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his study </a:t>
                      </a:r>
                      <a:endParaRPr kumimoji="0" lang="en-US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57781891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4f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D1214-AKS + Fusion 3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-</a:t>
                      </a:r>
                      <a:r>
                        <a:rPr lang="en-US" sz="12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lphafactor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TEF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CYC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his study </a:t>
                      </a:r>
                      <a:endParaRPr kumimoji="0" lang="en-US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4912880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5f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D1214-AT + Fusion 3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-</a:t>
                      </a:r>
                      <a:r>
                        <a:rPr lang="en-US" sz="12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lphafactor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TEF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CYC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his study </a:t>
                      </a:r>
                      <a:endParaRPr kumimoji="0" lang="en-US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36043428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6f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D1214-FAKS + Fusion 3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-</a:t>
                      </a:r>
                      <a:r>
                        <a:rPr lang="en-US" sz="12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lphafactor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TEF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CYC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his study </a:t>
                      </a:r>
                      <a:endParaRPr kumimoji="0" lang="en-US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43373817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7f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D1214-GA + Fusion 3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-</a:t>
                      </a:r>
                      <a:r>
                        <a:rPr lang="en-US" sz="12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lucoamylase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TEF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CYC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his study </a:t>
                      </a:r>
                      <a:endParaRPr kumimoji="0" lang="en-US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05730030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8f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D1214-IN + Fusion 3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m-</a:t>
                      </a:r>
                      <a:r>
                        <a:rPr lang="en-US" sz="12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ulinase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TEF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CYC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his study </a:t>
                      </a:r>
                      <a:endParaRPr kumimoji="0" lang="en-US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79394197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9f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D1214-IV + Fusion 3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-invertase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TEF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CYC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his study </a:t>
                      </a:r>
                      <a:endParaRPr kumimoji="0" lang="en-US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02337971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10f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D1214-KP + Fusion 3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-killer protei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TEF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CYC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his study </a:t>
                      </a:r>
                      <a:endParaRPr kumimoji="0" lang="en-US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29036264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11f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D1214-LZ + Fusion 3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ysozyme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TEF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CYC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his study </a:t>
                      </a:r>
                      <a:endParaRPr kumimoji="0" lang="en-US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20118578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ontrol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D1214-AA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-</a:t>
                      </a:r>
                      <a:r>
                        <a:rPr lang="en-US" sz="12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lphafactor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TEF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CYC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his study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47184398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6075AE62-55AF-4962-A621-12DC304B3842}"/>
              </a:ext>
            </a:extLst>
          </p:cNvPr>
          <p:cNvSpPr txBox="1"/>
          <p:nvPr/>
        </p:nvSpPr>
        <p:spPr>
          <a:xfrm>
            <a:off x="503547" y="908720"/>
            <a:ext cx="7920879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2. Plasmids used in this study.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GII indicates the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. reesei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GII,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eTr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BHI for a chimeric CBHI generated by fusion of the catalytic module from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alaromyces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mersonii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BHI with the linker peptide and cellulose-binding module from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. reesei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BHI.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spyk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presents native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. starkeyi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yruvate kinase promoter, Lsgal1 for the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. starkeyi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alactokinase terminator,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pDEXII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present native signal peptide of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. starkeyi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xtranase 2.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cTEF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cerevisia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anslation elongation factor 1 promoter. ScCYC1 =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cerevisia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ytochrome b-c1 complex terminator.</a:t>
            </a:r>
          </a:p>
        </p:txBody>
      </p:sp>
    </p:spTree>
    <p:extLst>
      <p:ext uri="{BB962C8B-B14F-4D97-AF65-F5344CB8AC3E}">
        <p14:creationId xmlns:p14="http://schemas.microsoft.com/office/powerpoint/2010/main" val="41119673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722</TotalTime>
  <Words>270</Words>
  <Application>Microsoft Office PowerPoint</Application>
  <PresentationFormat>On-screen Show (4:3)</PresentationFormat>
  <Paragraphs>10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Company>NRE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Qi Xu</dc:creator>
  <cp:lastModifiedBy>Markus Alahuhta</cp:lastModifiedBy>
  <cp:revision>381</cp:revision>
  <cp:lastPrinted>2018-01-22T23:31:45Z</cp:lastPrinted>
  <dcterms:created xsi:type="dcterms:W3CDTF">2016-03-04T20:59:15Z</dcterms:created>
  <dcterms:modified xsi:type="dcterms:W3CDTF">2018-02-27T17:52:51Z</dcterms:modified>
</cp:coreProperties>
</file>